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8A6CB-8A58-42FB-AC1B-88DB32E0BE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742B35-FA2E-49C5-8DB3-448C416280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920AA-C3D5-4EF5-854E-97361C5EBC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4B596-D274-4A3F-8AB2-A857CCF81D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8F37C-C1C4-4260-B147-D6A1E95C03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B4EDE-996E-4C06-AB18-C412DDE7FA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D7346-A055-4EE7-A637-8D12D9F629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288D0-A517-4500-B55A-B4BF47F831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36C4B-1B37-49E8-BF35-B69EF4E0B5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4E326-4346-4D54-AE83-AD54C4533C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32E0E-96B2-413F-B41C-F19D5CDCEC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AB164-9A93-478B-B92B-23D4D2D757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4DA47D-F1CB-458B-8F2A-9076E9C64D8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8"/>
          <p:cNvGrpSpPr/>
          <p:nvPr/>
        </p:nvGrpSpPr>
        <p:grpSpPr>
          <a:xfrm>
            <a:off x="981000" y="1258920"/>
            <a:ext cx="5040360" cy="9098280"/>
            <a:chOff x="981000" y="1258920"/>
            <a:chExt cx="5040360" cy="9098280"/>
          </a:xfrm>
        </p:grpSpPr>
        <p:sp>
          <p:nvSpPr>
            <p:cNvPr id="42" name="TextBox 4"/>
            <p:cNvSpPr/>
            <p:nvPr/>
          </p:nvSpPr>
          <p:spPr>
            <a:xfrm>
              <a:off x="981000" y="1258920"/>
              <a:ext cx="5040360" cy="909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TGACGCAGACCCCCGATCGGGAAAAGGCGCTCGAGCTGGCAGTGGCCCAGATCGAGAAGAGTTACGGCAAAGGTTCGGTGATGCGCCTCGGCGACGAGGCGCGTCAGCCGATTTCGGTCATTCCGACCGGATCCATCGCACTAGACGTGGCCCTGGGCATTGGCGGCCTGCCGCGTGGCCGGGTGATAGAGATATACGGCCCGGAGTCGTCGGGTAAGACCACCGTGGCGCTGCACGC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TGGCCAAC</a:t>
              </a:r>
              <a:r>
                <a:rPr b="1" lang="en-GB" sz="800" spc="-1" strike="noStrike">
                  <a:solidFill>
                    <a:srgbClr val="ff0000"/>
                  </a:solidFill>
                  <a:latin typeface="Courier New"/>
                  <a:ea typeface="Courier New"/>
                </a:rPr>
                <a:t>GCTCAGGCCGCCGGTGGTGTTG</a:t>
              </a:r>
              <a:r>
                <a:rPr b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GGCGTTCATCGACGCCGAGCACGCGCTGGATCCGGACTATGCCAAGA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CTCGGTGTCGACACCGATTCGCTGCTGGTCAGCCAGCCGGACACCGGGGAACAGGCACTCGAGATCGCCGACATGCTGATCCGCTCGGGTGCGCTTGACATCGTGGTGATCGACTCGGTGGCGGCGCTGGTGCCGCGCGCGGAGCTCGAAGGCGAGATGGGCGACAGCCACGTCGGGCtgcaggcccggctgatgagccaggcgctgcggaaaatgaccggcgcgctgaataattcgggcaccacggcgatcttcatcaaccagctccgcgacaagatcggagtgatgttcgggtcgcccgagacgacaacgggcggaaaggcgttgaagttctacgcgtcggtgcgcatggacgtgcggcgagtcgagacgctcaaggacggtaccaacgcggtcgg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accgcacccgggtcaaggtcgtcaagaacaag</a:t>
              </a:r>
              <a:r>
                <a:rPr b="1" lang="en-GB" sz="800" spc="-1" strike="noStrike" u="sng">
                  <a:solidFill>
                    <a:srgbClr val="ff0000"/>
                  </a:solidFill>
                  <a:uFillTx/>
                  <a:latin typeface="Courier New"/>
                  <a:ea typeface="Courier New"/>
                </a:rPr>
                <a:t>tgcctcgcagagggcactcgg</a:t>
              </a:r>
              <a:r>
                <a:rPr b="1" lang="en-GB" sz="8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atcttcgatccggtcaccggtacaa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Gcatcgcatcgaggatgttgtcgatgggcgcaagcctattcatgtcgtggctgctgccaaggacggaacgctgcatgcgcggcccgtggtgtcctggttcgaccagggaacgcgggatgtgatcgggttgcggatcgccggtggcgccatcgtgtgggcgacacccgatcacaaggtgctgacagagtacggctggcgtgccgccggggaactccgcaagggagacagggtggcgcaaccgcgacgcttcgatggattcggtgacagtgcgccgattccggcggatcatgcccggctgcttggctacctgatcggagatggcagggatggttgggtggggggcaagactccgatcaacttcatcaatgttcagcgggcgctcattgacgacgtgacgcgaatcgctgcgacgctcggttgcgcggcccatccgcaggggcgtatctcactcgcgatcgctcatcgacccggtgagcgcaacggtgtggcagacctttgtcagcaggccggtatctacggcaagctcgcgtgggagaagacgattccgaattggttcttcgagccggacatcgcggccgacattgtcggcaatctgctcttcggcctgttcgaaagcgacgggtgggtgagccgggaacagaccggggcacttcgggtcggttacacgacgacctctgaacaactcgcgcatcagattcattggctgctgctgcggttcggtgtcgggagcaccgttcgagattacgatccgacccagaagcggccgagcatcgtcaacggtcgacggatccagagcaaacgtcaagtgttcgaggtccggatctcgggtatggataacgtcacggcattcgcggagtcagttcccatgtgggggccgcg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gtgccgcgcttatccaggcgattccagaagccacgcaggggcggcgtcgtggatcgcaagcgacatatctggctgca</a:t>
              </a:r>
              <a:r>
                <a:rPr b="1" lang="en-GB" sz="800" spc="-1" strike="noStrike" u="sng">
                  <a:solidFill>
                    <a:srgbClr val="e46c0a"/>
                  </a:solidFill>
                  <a:uFillTx/>
                  <a:latin typeface="Courier New"/>
                  <a:ea typeface="Courier New"/>
                </a:rPr>
                <a:t>GAGATGACCGATGCCGTGCTGAATTATC</a:t>
              </a:r>
              <a:r>
                <a:rPr b="1" lang="en-GB" sz="8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GGACGAGCGCGGCGTGACCGCGCAGGAGGCCGCGGCCATGATCGGTGTAGCTTCCGGGGACCCCCGCGGTGGAATGAAGCAGGTCTTAGGTGCCAGCCGCCTTCGTCGGGATCGCGTGCAGGCGC</a:t>
              </a:r>
              <a:r>
                <a:rPr b="1" lang="en-GB" sz="800" spc="-1" strike="noStrike" u="sng">
                  <a:solidFill>
                    <a:srgbClr val="ff0000"/>
                  </a:solidFill>
                  <a:uFillTx/>
                  <a:latin typeface="Courier New"/>
                  <a:ea typeface="Courier New"/>
                </a:rPr>
                <a:t>TCGCGGATGCCCTGGATGACAAAT</a:t>
              </a:r>
              <a:r>
                <a:rPr b="1" lang="en-GB" sz="8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CCTGCACGACATGCTGGCGGAAGAACTCCGCTATTCCGTGATCCGAGAAGTGCTGCCAACGCGGCGGGCACGAACGTTCGACCTCGAGGTCGAGGAACTGCACACCCTCGTCG</a:t>
              </a:r>
              <a:r>
                <a:rPr b="1" lang="en-GB" sz="800" spc="-1" strike="noStrike" u="sng">
                  <a:solidFill>
                    <a:srgbClr val="7030a0"/>
                  </a:solidFill>
                  <a:uFillTx/>
                  <a:latin typeface="Courier New"/>
                  <a:ea typeface="Courier New"/>
                </a:rPr>
                <a:t>CCGAAGGGGTTGTCGTGCACAAC</a:t>
              </a:r>
              <a:r>
                <a:rPr b="1" lang="en-GB" sz="800" spc="-1" strike="noStrike">
                  <a:solidFill>
                    <a:srgbClr val="00b050"/>
                  </a:solidFill>
                  <a:latin typeface="Courier New"/>
                  <a:ea typeface="Courier New"/>
                </a:rPr>
                <a:t>TGTTCGCCCCCCTTCAAGCAGG</a:t>
              </a:r>
              <a:r>
                <a:rPr b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CGAGTTCGACATCCTCTACGGCAAGGGAATCAGCAGGGAGGGCTCGCTGATCGACATGGGTGT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ATCAGGGCCTCATCCGCAAGTCGGGTGCCTGGTTCACCTACGAGGGCGAGCAGCTCGGCCAGGGCAAGGAGAATGCCCGCAACTTCTTGGTGGAGAACGCCGACGTGGCTGACGAGATCGAGAAGAAGATCAAGGAAAAGCTTGGCATTGGTGCCGTG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7030a0"/>
                  </a:solidFill>
                  <a:latin typeface="Courier New"/>
                  <a:ea typeface="Courier New"/>
                </a:rPr>
                <a:t>TGACCGATGATCCCTCAA</a:t>
              </a:r>
              <a:r>
                <a:rPr b="1" i="1" lang="en-GB" sz="800" spc="-1" strike="noStrike" u="sng">
                  <a:solidFill>
                    <a:srgbClr val="7030a0"/>
                  </a:solidFill>
                  <a:uFillTx/>
                  <a:latin typeface="Courier New"/>
                  <a:ea typeface="Courier New"/>
                </a:rPr>
                <a:t>A</a:t>
              </a:r>
              <a:r>
                <a:rPr b="1" i="1" lang="en-GB" sz="8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GACGGTGTCCTGCCCGCCCCCGTCGACTTCTGA</a:t>
              </a:r>
              <a:r>
                <a:rPr b="1" i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CGCGAAGAGCAGGCGCGGGCACTGTGCCTGCGCCTGCTCACCGCGCGATCCC</a:t>
              </a:r>
              <a:r>
                <a:rPr b="1" i="1" lang="en-GB" sz="800" spc="-1" strike="noStrike">
                  <a:solidFill>
                    <a:srgbClr val="ff0000"/>
                  </a:solidFill>
                  <a:latin typeface="Courier New"/>
                  <a:ea typeface="Courier New"/>
                </a:rPr>
                <a:t>GCACCCGCGCCGAGTTAGC</a:t>
              </a:r>
              <a:r>
                <a:rPr b="1" i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GGCCAGCTGGCCAAGCGCGGCTACCCCGAAGACATCGGCAACCGGGTATTGGATCGGCTGGCCGCCGTTGGCCTGGTGGATGACACCGACTTCGCCGAACAATGGGT</a:t>
              </a:r>
              <a:r>
                <a:rPr b="1" i="1" lang="en-GB" sz="800" spc="-1" strike="noStrike">
                  <a:solidFill>
                    <a:srgbClr val="00b0f0"/>
                  </a:solidFill>
                  <a:latin typeface="Courier New"/>
                  <a:ea typeface="Courier New"/>
                </a:rPr>
                <a:t>TCAGTCCAGGCGGGCGAACG</a:t>
              </a:r>
              <a:r>
                <a:rPr b="1" i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AGCAAAGAGCAAGCGCGCGTTGGCTGCCGAGCTGCACGCCAAGGGCGTCGACGACGACGTGATCA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ACGGTGCTCGGGGGCATCGACGCCGGTGCCGAACGGGGGCGGGCGGAAAAGCTGGTACGGGCCAGGCTGCGGCGGGAGGTGCTGATCGACGACGGCACCGACGAAGCGCGGGTGAGCCGCAGGCTGGTGGCGATGTTGGCGCGCCGTGGGTACGGCCAGACCTTGGCGTGCGAGGTGGTTATCGCCGAGCTGGCCGCCGAGCGGGAGCGCCGACGCGTCTA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5"/>
            <p:cNvSpPr/>
            <p:nvPr/>
          </p:nvSpPr>
          <p:spPr>
            <a:xfrm>
              <a:off x="1387440" y="7198200"/>
              <a:ext cx="360000" cy="92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6"/>
            <p:cNvSpPr/>
            <p:nvPr/>
          </p:nvSpPr>
          <p:spPr>
            <a:xfrm>
              <a:off x="4822920" y="6966360"/>
              <a:ext cx="360000" cy="92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Oval 7"/>
            <p:cNvSpPr/>
            <p:nvPr/>
          </p:nvSpPr>
          <p:spPr>
            <a:xfrm>
              <a:off x="2160000" y="7183080"/>
              <a:ext cx="68760" cy="11412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" name="TextBox 9"/>
          <p:cNvSpPr/>
          <p:nvPr/>
        </p:nvSpPr>
        <p:spPr>
          <a:xfrm>
            <a:off x="2021400" y="1790640"/>
            <a:ext cx="51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0000"/>
                </a:solidFill>
                <a:latin typeface="Calibri"/>
              </a:rPr>
              <a:t>recA_F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3450240" y="2952720"/>
            <a:ext cx="51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0000"/>
                </a:solidFill>
                <a:latin typeface="Calibri"/>
              </a:rPr>
              <a:t>recA_F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1583280" y="5438880"/>
            <a:ext cx="51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e46c0a"/>
                </a:solidFill>
                <a:latin typeface="Calibri"/>
              </a:rPr>
              <a:t>recA_F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1221480" y="5934240"/>
            <a:ext cx="51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0000"/>
                </a:solidFill>
                <a:latin typeface="Calibri"/>
              </a:rPr>
              <a:t>recA_F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1279440" y="776304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b0f0"/>
                </a:solidFill>
                <a:latin typeface="Calibri"/>
              </a:rPr>
              <a:t>recX_R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2916720" y="7277040"/>
            <a:ext cx="51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ff0000"/>
                </a:solidFill>
                <a:latin typeface="Calibri"/>
              </a:rPr>
              <a:t>recX_F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1193400" y="6419880"/>
            <a:ext cx="65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b050"/>
                </a:solidFill>
                <a:latin typeface="Calibri"/>
              </a:rPr>
              <a:t>recX_Pr2_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6"/>
          <p:cNvSpPr/>
          <p:nvPr/>
        </p:nvSpPr>
        <p:spPr>
          <a:xfrm>
            <a:off x="4548240" y="6172200"/>
            <a:ext cx="52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7030a0"/>
                </a:solidFill>
                <a:latin typeface="Calibri"/>
              </a:rPr>
              <a:t>Intein_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7"/>
          <p:cNvSpPr/>
          <p:nvPr/>
        </p:nvSpPr>
        <p:spPr>
          <a:xfrm>
            <a:off x="1289880" y="7010280"/>
            <a:ext cx="55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7030a0"/>
                </a:solidFill>
                <a:latin typeface="Calibri"/>
              </a:rPr>
              <a:t>recX_Pr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4T14:52:59Z</dcterms:created>
  <dc:creator>Elaine Davis</dc:creator>
  <dc:description/>
  <dc:language>en-US</dc:language>
  <cp:lastModifiedBy>3316</cp:lastModifiedBy>
  <dcterms:modified xsi:type="dcterms:W3CDTF">2010-11-20T13:43:03Z</dcterms:modified>
  <cp:revision>17</cp:revision>
  <dc:subject/>
  <dc:title>Slide 1</dc:title>
</cp:coreProperties>
</file>